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492" y="10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8ABB6F9-D2C4-42DE-B1D1-29B52A9175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90FF6FB-A193-41A1-813B-5289D27595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E5306E-1956-4F16-8E95-094EB8849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3EE63B3-0B63-4A75-A762-96A59B810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01B6051-DFB2-453C-BE73-62B91E537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581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6171F45-58A0-439D-A1E6-698E2D59E5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97C7FF4-92EA-4A5D-A5AC-6A213505DD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E13F437-9F11-4230-B30E-45CA0FB43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6B68BF5-C1F1-4F6B-9502-2DCC06A9C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F8A7D23-5A52-4928-9E6F-B89A04279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280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076ED60-E5D2-47B5-8471-E108905544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73CE4C2-A7E5-4316-924F-715A92FE82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7199835-A76D-4872-A0DC-43AC8F77B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5260CCD-4371-4A7B-A976-2D27B678D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74B0337-44E1-451D-B9DC-5FE0D45C2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352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15E84E-94DB-4AA7-84D1-7EE29D4FEC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24F73E0-0D7A-487D-B464-B2558FF479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076593A-E951-48D1-8B20-C87A63133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8AE76D8-04D7-4416-BA98-712070B37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98B033-D520-4479-AF67-B6F855DAA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50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23B6002-6BEF-4BCB-83C6-F4B4D08E0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6074D0D-76BB-49C8-893F-A934D1B8F3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B211C50-86FE-4528-9AB9-389915EF8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6B2A1A9-ED7C-4E28-A50A-6EED10DC4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4144318-3FE7-403C-A7A2-6115793FD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850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9E2A62-EB11-4C1D-B2DA-DADFBA04E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9B0114C-E6D8-405B-8CF7-D65C09D029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17BB933-5E4A-407A-BC89-DA5C511767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240DBA9-0C54-49C6-A010-F618353E3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03957BC-CDD4-4B8B-B09E-D64ACF6AB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91E900B-E2D9-4553-97EA-DB564CA15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04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6C854CF-4777-482A-83EE-12505056A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2B1E286-7DD1-454C-88F8-C6078782D2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B5970D2-4EBA-48D7-A40E-E99356FE24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A255869-3955-4E8B-8456-836AE58D7B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645DAD5-0BE0-46DC-8FA9-6690A6C45C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9BD563D-D657-4F25-BF1F-EA70EDA2A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E6E2903-2218-447F-88AF-029B990EC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4971E42-DE97-4F91-B908-A2446F4F8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051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964B5A0-50BF-4129-BE46-52087F539F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CD51FE0-A38C-41AA-B58D-657918E85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6535AB5-691E-4CCA-A306-899423C2B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C0817D4-8ED1-4CFD-83FD-B5267346F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07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C936527-42C6-44D2-AA80-23EB36ED3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45E0664-1A7E-433A-B1D3-9C5E5D2C8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5158CF14-F221-428D-947B-8636CC4B1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461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DEA267A-4E96-4134-9644-D1B4F46466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AA604DF-0DFC-4E6A-A6C3-E85B86E4A7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562A027-E236-40CB-B60E-2493B3FB73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EBA056B-3695-41DC-8667-F10C16F62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AABC1B2-7F0E-4A37-82CC-81322A54D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7C88402-1F54-4322-8380-1789873B5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326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DD354B5-664F-4E5A-811A-810407A48F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12086C9-FAC3-4AFF-80D2-7F1B96BD70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D43D613-2CEB-4F57-8B85-B1673EF960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AF3A294-ABDB-40FA-98B1-C9008A656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4ADFD72-68A9-4658-865C-1FD2314D5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B1B6D1F-4228-4711-89AA-3B6F5D08C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115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BB528D7-436C-4A1A-871C-22BB2C57D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B709F1D-B417-4C32-95C7-F0D627E596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8DF2BC5-C226-4A6C-B9C0-8C8EF5EF77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683BD-CF25-4E3F-AF73-7DFFF229FAB9}" type="datetimeFigureOut">
              <a:rPr lang="en-US" smtClean="0"/>
              <a:t>6/7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EF78E6E-CF4D-4FE2-A02A-38FEF4D1A4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38044BC-3797-4389-B211-71D9ED2B2A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967359-1BB1-4C47-94A9-ADCB8038B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798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3954C514-8158-4E60-9B87-D147AFAD226F}"/>
              </a:ext>
            </a:extLst>
          </p:cNvPr>
          <p:cNvSpPr txBox="1"/>
          <p:nvPr/>
        </p:nvSpPr>
        <p:spPr>
          <a:xfrm>
            <a:off x="2740294" y="1022485"/>
            <a:ext cx="121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9D61810-69DA-4A61-B958-873C13EAE044}"/>
              </a:ext>
            </a:extLst>
          </p:cNvPr>
          <p:cNvSpPr txBox="1"/>
          <p:nvPr/>
        </p:nvSpPr>
        <p:spPr>
          <a:xfrm>
            <a:off x="5622832" y="1022484"/>
            <a:ext cx="121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73D43E6-953E-421C-BCFF-A11FD9FD968D}"/>
              </a:ext>
            </a:extLst>
          </p:cNvPr>
          <p:cNvSpPr txBox="1"/>
          <p:nvPr/>
        </p:nvSpPr>
        <p:spPr>
          <a:xfrm>
            <a:off x="8717200" y="1022483"/>
            <a:ext cx="121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BA973305-8740-4855-A3E3-E8CCD8E0A737}"/>
              </a:ext>
            </a:extLst>
          </p:cNvPr>
          <p:cNvSpPr txBox="1"/>
          <p:nvPr/>
        </p:nvSpPr>
        <p:spPr>
          <a:xfrm>
            <a:off x="286547" y="226423"/>
            <a:ext cx="1159168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Figure S1: </a:t>
            </a:r>
            <a:r>
              <a:rPr lang="en-US" sz="1400" dirty="0" err="1"/>
              <a:t>sSuccessful</a:t>
            </a:r>
            <a:r>
              <a:rPr lang="en-US" sz="1400" dirty="0"/>
              <a:t> and required supporting measures according to stakeholders of a) conventional and b) free-range broiler farms, c) turkey farms, d) conventional and e) free-range layer farms, and f) breeder farms expressed as cumulative percentage (%).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8CD71347-0C24-426B-96E5-CD5F17C5AC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84" y="1176371"/>
            <a:ext cx="5672861" cy="5667768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A8DD5893-E4E4-4B4F-9428-FE9A0DD9BF8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567"/>
          <a:stretch/>
        </p:blipFill>
        <p:spPr>
          <a:xfrm>
            <a:off x="5834662" y="1176371"/>
            <a:ext cx="2917711" cy="5667768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8F495E14-2DB6-457B-BFBF-37F122A462B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525"/>
          <a:stretch/>
        </p:blipFill>
        <p:spPr>
          <a:xfrm>
            <a:off x="8839121" y="1176371"/>
            <a:ext cx="3426687" cy="5667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2138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3954C514-8158-4E60-9B87-D147AFAD226F}"/>
              </a:ext>
            </a:extLst>
          </p:cNvPr>
          <p:cNvSpPr txBox="1"/>
          <p:nvPr/>
        </p:nvSpPr>
        <p:spPr>
          <a:xfrm>
            <a:off x="2760614" y="565285"/>
            <a:ext cx="121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9D61810-69DA-4A61-B958-873C13EAE044}"/>
              </a:ext>
            </a:extLst>
          </p:cNvPr>
          <p:cNvSpPr txBox="1"/>
          <p:nvPr/>
        </p:nvSpPr>
        <p:spPr>
          <a:xfrm>
            <a:off x="5643152" y="565284"/>
            <a:ext cx="121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E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73D43E6-953E-421C-BCFF-A11FD9FD968D}"/>
              </a:ext>
            </a:extLst>
          </p:cNvPr>
          <p:cNvSpPr txBox="1"/>
          <p:nvPr/>
        </p:nvSpPr>
        <p:spPr>
          <a:xfrm>
            <a:off x="8628651" y="565283"/>
            <a:ext cx="1219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</a:t>
            </a:r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77CF85DF-E376-49D2-8E40-45B4D908C7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19171"/>
            <a:ext cx="5672861" cy="5667768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22F22384-AEDD-4C71-9115-2AE996177E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567"/>
          <a:stretch/>
        </p:blipFill>
        <p:spPr>
          <a:xfrm>
            <a:off x="5832861" y="719171"/>
            <a:ext cx="2917711" cy="5667768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21B8BDA9-A957-4E9D-8E89-2A2BF55EE93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643"/>
          <a:stretch/>
        </p:blipFill>
        <p:spPr>
          <a:xfrm>
            <a:off x="8818360" y="719171"/>
            <a:ext cx="3419428" cy="5667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36543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3</Words>
  <Application>Microsoft Office PowerPoint</Application>
  <PresentationFormat>Widescreen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MDPI</cp:lastModifiedBy>
  <cp:revision>5</cp:revision>
  <dcterms:created xsi:type="dcterms:W3CDTF">2024-04-09T14:19:29Z</dcterms:created>
  <dcterms:modified xsi:type="dcterms:W3CDTF">2024-06-07T01:11:22Z</dcterms:modified>
</cp:coreProperties>
</file>